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84201"/>
  </p:normalViewPr>
  <p:slideViewPr>
    <p:cSldViewPr snapToGrid="0" snapToObjects="1">
      <p:cViewPr varScale="1">
        <p:scale>
          <a:sx n="101" d="100"/>
          <a:sy n="101" d="100"/>
        </p:scale>
        <p:origin x="232" y="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B69E37-C59B-B348-B051-EE389495585E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D6D64-4201-BD42-BC82-5D1E8ED66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226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defRPr/>
            </a:pPr>
            <a:fld id="{11139F6A-FB59-5A48-A80B-C997DA68CCA6}" type="slidenum">
              <a:rPr lang="en-US" sz="1200">
                <a:solidFill>
                  <a:srgbClr val="000000"/>
                </a:solidFill>
              </a:rPr>
              <a:pPr defTabSz="914400" eaLnBrk="1" fontAlgn="base" hangingPunct="1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 sz="1200">
              <a:solidFill>
                <a:srgbClr val="000000"/>
              </a:solidFill>
            </a:endParaRPr>
          </a:p>
        </p:txBody>
      </p:sp>
      <p:sp>
        <p:nvSpPr>
          <p:cNvPr id="1536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ln/>
        </p:spPr>
      </p:sp>
      <p:sp>
        <p:nvSpPr>
          <p:cNvPr id="1536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en-US" sz="1200" b="1" kern="120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Supplementary Fig 12b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: 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Stress condition </a:t>
            </a:r>
            <a:r>
              <a:rPr lang="en-US" b="1" baseline="0" dirty="0">
                <a:latin typeface="Arial" charset="0"/>
                <a:ea typeface="ＭＳ Ｐゴシック" charset="0"/>
                <a:cs typeface="ＭＳ Ｐゴシック" charset="0"/>
              </a:rPr>
              <a:t>differences by binge eating group for high-ED vs. low-ED food contras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Both columns illustrate areas showing differential activation for the high-ED vs low-ED contrast between stress and non-stress conditions, with effects for the NB group shown on the left column, and effects for the BE group on the right column; 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dlPFC indicates dorsolateral prefrontal cortex; Cu, cuneus; Sens-Mot, sensorimotor cortex; MTG, middle temporal gyrus; OFC, orbitofrontal cortex; IFG, inferior frontal gyrus.</a:t>
            </a:r>
          </a:p>
          <a:p>
            <a:r>
              <a:rPr lang="en-US" b="1" baseline="0" dirty="0">
                <a:latin typeface="Arial" charset="0"/>
                <a:ea typeface="ＭＳ Ｐゴシック" charset="0"/>
                <a:cs typeface="ＭＳ Ｐゴシック" charset="0"/>
              </a:rPr>
              <a:t> </a:t>
            </a:r>
            <a:endParaRPr lang="en-US" b="1" dirty="0">
              <a:latin typeface="Arial" charset="0"/>
              <a:ea typeface="ＭＳ Ｐゴシック" charset="0"/>
              <a:cs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42624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0F2C8-7675-0642-A16C-4A1AF148D8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2CED4B-BEFE-F940-9C7A-CD73253C35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F34A5-25E2-B447-A53F-9D073353C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360D2-C67F-C344-8750-90720D270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3D513-73C0-064B-ACFB-0CD31BBB3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684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A7C21-050C-4045-B9F2-6D15D88BE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863D30-3ED2-534E-B147-B47FA7B8F7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F94A0-AB30-F940-8077-8D85C74E4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3FD6D-8140-EC4A-8EAE-20D09AAD7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6BA17F-104B-7245-B6AB-4E35888AE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22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A04A82-733E-A243-8105-DE4FD7FDC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6604C-882A-3A4A-9FE0-FE83ED19F4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9A4B4-6917-F940-8ACF-2FCFD746D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B4ACE-77C5-DC41-A118-B7B70BAC0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0A29F-433C-B04D-BB3E-3399305D4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30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0E4B0-6E96-C84B-A3AC-F3135A28F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54D220-4A31-7C45-B2D5-C175828D33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EE3EE-4221-A64A-A74A-B771152A0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0F6FF6-04A3-414C-BC56-DFEEC160F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E2E7C-1087-7645-BA81-F17C7C84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101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D2464-FD62-9C46-A480-8D6BD3B50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7BBDD6-A130-5945-BDE9-7CA58DDDC5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0F79F7-24F3-F84D-9E88-B2E39E614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47250-D516-8647-83D6-BBBC0E655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AFE0C-07A4-F64C-BF98-8FD27540E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02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14193-C656-DC46-B8A9-B222FF13EB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1A7DBE-8998-3A4D-B673-039F0088AD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60B051-E8C6-984C-80BC-143185EE4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08911C-93BF-4243-A980-F865C2001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5D9BC-102C-124D-949A-472C7255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C95380-B911-D14F-AA33-5DAFB0276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2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B82FA-7F5D-C24A-9B4D-182913A14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2DF9F-EC62-934C-9395-186CF6E16E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F69212-6AA7-6543-BB6F-E720EE1A71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701836-2BA1-2945-9ECF-DEB842F702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8A43C2-629C-0242-9FE9-645395A6FD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5AC270-23AB-A248-8246-DB62E97C9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C7D824-A912-E34C-8A41-99E2B5A0E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5C3A9-C395-464B-A478-15D773A85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11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81D94-83EF-A04C-A85F-E09823926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CF3099-B0D0-354E-BC13-B6A23468F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995B67-1D64-334B-B516-F8F46E0E0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6DA786-63E2-A049-85CD-359BD4E8E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81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7D6F75-B4E9-B547-980B-FC2537D33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E4B715-FA60-4F44-BA94-D1B505102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5C863A-B507-AD4E-8F5F-F9601055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204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B7134-60A9-8A46-B94F-C10143890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B620D0-4FB1-6044-BB3E-88172B24D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7BB0E6-7FD1-AC48-A895-3B3AF16884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E33AA-CF53-074D-A527-ECD01CD40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50A1CD-59D1-174F-AB97-E54F9D8A3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53175B-9859-A040-907A-F226AD849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95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8806D6-7E52-044F-903F-C79DA9487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380736-3B1D-4C4D-B3D3-5CD9299972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4294F-49AF-084D-AB23-77441BB377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178F24-50CF-0146-ADE0-4A8672549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10A44-C307-3546-9256-B78B18CD6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A5BCF7-7C11-684F-AD2C-9FB61EE3E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37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F48FCB-C307-AC46-8F6D-BD8682C14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23C883-8B6A-9244-8646-D179FDCD7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8730C-28DB-E845-BC46-5170EA59F9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75CF5-27E2-9743-8AA5-3CCFC205BC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6EBC5B-EE2C-424C-A5A4-EAAD26F7E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80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73" name="Line 53"/>
          <p:cNvSpPr>
            <a:spLocks noChangeShapeType="1"/>
          </p:cNvSpPr>
          <p:nvPr/>
        </p:nvSpPr>
        <p:spPr bwMode="auto">
          <a:xfrm flipH="1">
            <a:off x="6096001" y="1487249"/>
            <a:ext cx="4293" cy="2581514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pPr defTabSz="914428"/>
            <a:endParaRPr lang="en-US">
              <a:solidFill>
                <a:srgbClr val="000000"/>
              </a:solidFill>
              <a:cs typeface="+mn-cs"/>
            </a:endParaRPr>
          </a:p>
        </p:txBody>
      </p:sp>
      <p:sp>
        <p:nvSpPr>
          <p:cNvPr id="61" name="Text Box 3">
            <a:extLst>
              <a:ext uri="{FF2B5EF4-FFF2-40B4-BE49-F238E27FC236}">
                <a16:creationId xmlns:a16="http://schemas.microsoft.com/office/drawing/2014/main" id="{0B85E99B-AE1F-D94F-8B89-5765AEFF73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0110" y="1388830"/>
            <a:ext cx="33161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Stress &gt; Non Stress Condition</a:t>
            </a:r>
          </a:p>
        </p:txBody>
      </p:sp>
      <p:sp>
        <p:nvSpPr>
          <p:cNvPr id="62" name="Text Box 14">
            <a:extLst>
              <a:ext uri="{FF2B5EF4-FFF2-40B4-BE49-F238E27FC236}">
                <a16:creationId xmlns:a16="http://schemas.microsoft.com/office/drawing/2014/main" id="{C483B93E-64E2-AD48-AF5E-423CB47AA4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92801" y="1127097"/>
            <a:ext cx="2590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FF"/>
                </a:solidFill>
              </a:rPr>
              <a:t>Non-BE</a:t>
            </a:r>
          </a:p>
        </p:txBody>
      </p:sp>
      <p:sp>
        <p:nvSpPr>
          <p:cNvPr id="63" name="Text Box 14">
            <a:extLst>
              <a:ext uri="{FF2B5EF4-FFF2-40B4-BE49-F238E27FC236}">
                <a16:creationId xmlns:a16="http://schemas.microsoft.com/office/drawing/2014/main" id="{FB2780D0-A89F-4145-A78F-0A30C49948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11401" y="1131509"/>
            <a:ext cx="2590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FF"/>
                </a:solidFill>
              </a:rPr>
              <a:t>BE</a:t>
            </a:r>
          </a:p>
        </p:txBody>
      </p:sp>
      <p:sp>
        <p:nvSpPr>
          <p:cNvPr id="68" name="Text Box 3">
            <a:extLst>
              <a:ext uri="{FF2B5EF4-FFF2-40B4-BE49-F238E27FC236}">
                <a16:creationId xmlns:a16="http://schemas.microsoft.com/office/drawing/2014/main" id="{FAC3EF9A-3D81-564C-91DE-45906DC3D4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87150" y="1383181"/>
            <a:ext cx="33161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Stress &gt; Non Stress Condition</a:t>
            </a:r>
          </a:p>
        </p:txBody>
      </p:sp>
      <p:sp>
        <p:nvSpPr>
          <p:cNvPr id="74" name="Text Box 14">
            <a:extLst>
              <a:ext uri="{FF2B5EF4-FFF2-40B4-BE49-F238E27FC236}">
                <a16:creationId xmlns:a16="http://schemas.microsoft.com/office/drawing/2014/main" id="{2DE5ADE6-4B23-2B42-9013-15870393B5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0000" y="533401"/>
            <a:ext cx="46482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High-ED &gt; Low-ED</a:t>
            </a:r>
          </a:p>
        </p:txBody>
      </p:sp>
      <p:grpSp>
        <p:nvGrpSpPr>
          <p:cNvPr id="75" name="Group 74">
            <a:extLst>
              <a:ext uri="{FF2B5EF4-FFF2-40B4-BE49-F238E27FC236}">
                <a16:creationId xmlns:a16="http://schemas.microsoft.com/office/drawing/2014/main" id="{CE85E56F-AFCF-3444-AB31-FAF0964C250A}"/>
              </a:ext>
            </a:extLst>
          </p:cNvPr>
          <p:cNvGrpSpPr/>
          <p:nvPr/>
        </p:nvGrpSpPr>
        <p:grpSpPr>
          <a:xfrm>
            <a:off x="4054945" y="1972986"/>
            <a:ext cx="967593" cy="1042458"/>
            <a:chOff x="1448757" y="1609720"/>
            <a:chExt cx="967592" cy="1042458"/>
          </a:xfrm>
        </p:grpSpPr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18F41FBF-58AA-B943-B663-5EB4954E833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48757" y="1609720"/>
              <a:ext cx="875872" cy="1037719"/>
            </a:xfrm>
            <a:prstGeom prst="rect">
              <a:avLst/>
            </a:prstGeom>
          </p:spPr>
        </p:pic>
        <p:sp>
          <p:nvSpPr>
            <p:cNvPr id="94" name="Oval 93">
              <a:extLst>
                <a:ext uri="{FF2B5EF4-FFF2-40B4-BE49-F238E27FC236}">
                  <a16:creationId xmlns:a16="http://schemas.microsoft.com/office/drawing/2014/main" id="{2EFC8BAC-00B8-6247-8091-FF6276EB8E01}"/>
                </a:ext>
              </a:extLst>
            </p:cNvPr>
            <p:cNvSpPr/>
            <p:nvPr/>
          </p:nvSpPr>
          <p:spPr>
            <a:xfrm>
              <a:off x="2232909" y="2537451"/>
              <a:ext cx="183440" cy="11472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91422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7" name="TextBox 20">
            <a:extLst>
              <a:ext uri="{FF2B5EF4-FFF2-40B4-BE49-F238E27FC236}">
                <a16:creationId xmlns:a16="http://schemas.microsoft.com/office/drawing/2014/main" id="{F31FA004-7E6A-7E4F-8BBA-F837DE21AA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13001" y="1971544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dlPFC</a:t>
            </a:r>
          </a:p>
        </p:txBody>
      </p: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787BF003-0686-C940-81C5-6740D817D46D}"/>
              </a:ext>
            </a:extLst>
          </p:cNvPr>
          <p:cNvCxnSpPr>
            <a:cxnSpLocks/>
          </p:cNvCxnSpPr>
          <p:nvPr/>
        </p:nvCxnSpPr>
        <p:spPr>
          <a:xfrm>
            <a:off x="3626516" y="2127832"/>
            <a:ext cx="542802" cy="62254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TextBox 40">
            <a:extLst>
              <a:ext uri="{FF2B5EF4-FFF2-40B4-BE49-F238E27FC236}">
                <a16:creationId xmlns:a16="http://schemas.microsoft.com/office/drawing/2014/main" id="{69615535-3328-8041-A883-9C6F7CD2F5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59407" y="2769224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28</a:t>
            </a:r>
          </a:p>
        </p:txBody>
      </p:sp>
      <p:pic>
        <p:nvPicPr>
          <p:cNvPr id="101" name="Picture 100">
            <a:extLst>
              <a:ext uri="{FF2B5EF4-FFF2-40B4-BE49-F238E27FC236}">
                <a16:creationId xmlns:a16="http://schemas.microsoft.com/office/drawing/2014/main" id="{19B12FEB-5D56-AE49-9B82-BE863936CCE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80290" y="3080271"/>
            <a:ext cx="843960" cy="1003374"/>
          </a:xfrm>
          <a:prstGeom prst="rect">
            <a:avLst/>
          </a:prstGeom>
        </p:spPr>
      </p:pic>
      <p:sp>
        <p:nvSpPr>
          <p:cNvPr id="102" name="TextBox 40">
            <a:extLst>
              <a:ext uri="{FF2B5EF4-FFF2-40B4-BE49-F238E27FC236}">
                <a16:creationId xmlns:a16="http://schemas.microsoft.com/office/drawing/2014/main" id="{8DA916B3-9898-F745-8E96-308DA19298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28634" y="3880987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34</a:t>
            </a:r>
          </a:p>
        </p:txBody>
      </p:sp>
      <p:sp>
        <p:nvSpPr>
          <p:cNvPr id="103" name="TextBox 29">
            <a:extLst>
              <a:ext uri="{FF2B5EF4-FFF2-40B4-BE49-F238E27FC236}">
                <a16:creationId xmlns:a16="http://schemas.microsoft.com/office/drawing/2014/main" id="{3B439681-9157-A745-8778-963688AE24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23054" y="3702135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Cu</a:t>
            </a:r>
          </a:p>
        </p:txBody>
      </p: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D08A148A-9167-0F4F-804D-B3D1507E3AD6}"/>
              </a:ext>
            </a:extLst>
          </p:cNvPr>
          <p:cNvCxnSpPr>
            <a:cxnSpLocks/>
          </p:cNvCxnSpPr>
          <p:nvPr/>
        </p:nvCxnSpPr>
        <p:spPr>
          <a:xfrm>
            <a:off x="3408838" y="3840633"/>
            <a:ext cx="1130324" cy="15040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9" name="TextBox 29">
            <a:extLst>
              <a:ext uri="{FF2B5EF4-FFF2-40B4-BE49-F238E27FC236}">
                <a16:creationId xmlns:a16="http://schemas.microsoft.com/office/drawing/2014/main" id="{8C0CE069-94C9-B847-A583-2459A8F332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7824" y="3079891"/>
            <a:ext cx="117297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Sens-</a:t>
            </a:r>
          </a:p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Mot</a:t>
            </a:r>
          </a:p>
        </p:txBody>
      </p: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D6A4CE5C-DB67-9A4F-9A00-7B825FAEACCB}"/>
              </a:ext>
            </a:extLst>
          </p:cNvPr>
          <p:cNvCxnSpPr>
            <a:cxnSpLocks/>
            <a:stCxn id="109" idx="1"/>
          </p:cNvCxnSpPr>
          <p:nvPr/>
        </p:nvCxnSpPr>
        <p:spPr>
          <a:xfrm flipH="1">
            <a:off x="4849666" y="3310724"/>
            <a:ext cx="378158" cy="134779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99D4532E-D926-3844-A219-5787FD0BA285}"/>
              </a:ext>
            </a:extLst>
          </p:cNvPr>
          <p:cNvGrpSpPr/>
          <p:nvPr/>
        </p:nvGrpSpPr>
        <p:grpSpPr>
          <a:xfrm>
            <a:off x="7115945" y="1977335"/>
            <a:ext cx="952937" cy="1042458"/>
            <a:chOff x="1463413" y="1609720"/>
            <a:chExt cx="952936" cy="1042458"/>
          </a:xfrm>
        </p:grpSpPr>
        <p:pic>
          <p:nvPicPr>
            <p:cNvPr id="119" name="Picture 118">
              <a:extLst>
                <a:ext uri="{FF2B5EF4-FFF2-40B4-BE49-F238E27FC236}">
                  <a16:creationId xmlns:a16="http://schemas.microsoft.com/office/drawing/2014/main" id="{DB9EE76C-71F2-5F40-A2D4-66E26A8512B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63413" y="1609720"/>
              <a:ext cx="846559" cy="1037719"/>
            </a:xfrm>
            <a:prstGeom prst="rect">
              <a:avLst/>
            </a:prstGeom>
          </p:spPr>
        </p:pic>
        <p:sp>
          <p:nvSpPr>
            <p:cNvPr id="120" name="Oval 119">
              <a:extLst>
                <a:ext uri="{FF2B5EF4-FFF2-40B4-BE49-F238E27FC236}">
                  <a16:creationId xmlns:a16="http://schemas.microsoft.com/office/drawing/2014/main" id="{0781790B-9647-A046-92CA-796702BCE62E}"/>
                </a:ext>
              </a:extLst>
            </p:cNvPr>
            <p:cNvSpPr/>
            <p:nvPr/>
          </p:nvSpPr>
          <p:spPr>
            <a:xfrm>
              <a:off x="2232909" y="2537451"/>
              <a:ext cx="183440" cy="11472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91422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21" name="TextBox 20">
            <a:extLst>
              <a:ext uri="{FF2B5EF4-FFF2-40B4-BE49-F238E27FC236}">
                <a16:creationId xmlns:a16="http://schemas.microsoft.com/office/drawing/2014/main" id="{37E53587-0A67-AD42-988C-0A2D9571DD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22712" y="2192586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MTG</a:t>
            </a:r>
          </a:p>
        </p:txBody>
      </p: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182457C7-D90F-4D40-8C93-08EFC86405CB}"/>
              </a:ext>
            </a:extLst>
          </p:cNvPr>
          <p:cNvCxnSpPr>
            <a:cxnSpLocks/>
          </p:cNvCxnSpPr>
          <p:nvPr/>
        </p:nvCxnSpPr>
        <p:spPr>
          <a:xfrm flipH="1">
            <a:off x="7873944" y="2432127"/>
            <a:ext cx="543075" cy="68645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" name="TextBox 40">
            <a:extLst>
              <a:ext uri="{FF2B5EF4-FFF2-40B4-BE49-F238E27FC236}">
                <a16:creationId xmlns:a16="http://schemas.microsoft.com/office/drawing/2014/main" id="{E869E324-15A5-A04E-B32E-417EEFB6DC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05751" y="2773573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-16</a:t>
            </a:r>
          </a:p>
        </p:txBody>
      </p:sp>
      <p:pic>
        <p:nvPicPr>
          <p:cNvPr id="124" name="Picture 123">
            <a:extLst>
              <a:ext uri="{FF2B5EF4-FFF2-40B4-BE49-F238E27FC236}">
                <a16:creationId xmlns:a16="http://schemas.microsoft.com/office/drawing/2014/main" id="{92A31DDD-2CAC-424F-84A0-17D766C0EFE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27023" y="3080271"/>
            <a:ext cx="792581" cy="1003374"/>
          </a:xfrm>
          <a:prstGeom prst="rect">
            <a:avLst/>
          </a:prstGeom>
        </p:spPr>
      </p:pic>
      <p:sp>
        <p:nvSpPr>
          <p:cNvPr id="125" name="TextBox 40">
            <a:extLst>
              <a:ext uri="{FF2B5EF4-FFF2-40B4-BE49-F238E27FC236}">
                <a16:creationId xmlns:a16="http://schemas.microsoft.com/office/drawing/2014/main" id="{3EAC792F-AF86-6644-B94E-EC38EE3D0A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978" y="3885336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-2</a:t>
            </a:r>
          </a:p>
        </p:txBody>
      </p:sp>
      <p:sp>
        <p:nvSpPr>
          <p:cNvPr id="128" name="TextBox 29">
            <a:extLst>
              <a:ext uri="{FF2B5EF4-FFF2-40B4-BE49-F238E27FC236}">
                <a16:creationId xmlns:a16="http://schemas.microsoft.com/office/drawing/2014/main" id="{6855EC6E-7625-A840-B203-3A76E11C11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17019" y="3563635"/>
            <a:ext cx="6373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IFG</a:t>
            </a:r>
          </a:p>
        </p:txBody>
      </p: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EAA63FCF-E82A-4444-A2FA-6078CDEB9582}"/>
              </a:ext>
            </a:extLst>
          </p:cNvPr>
          <p:cNvCxnSpPr>
            <a:cxnSpLocks/>
          </p:cNvCxnSpPr>
          <p:nvPr/>
        </p:nvCxnSpPr>
        <p:spPr>
          <a:xfrm flipH="1" flipV="1">
            <a:off x="7851455" y="3418626"/>
            <a:ext cx="556854" cy="261364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0" name="TextBox 29">
            <a:extLst>
              <a:ext uri="{FF2B5EF4-FFF2-40B4-BE49-F238E27FC236}">
                <a16:creationId xmlns:a16="http://schemas.microsoft.com/office/drawing/2014/main" id="{7AC89809-C811-0F43-BB1B-8DE32EE49A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17018" y="3141628"/>
            <a:ext cx="51380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OFC</a:t>
            </a:r>
          </a:p>
        </p:txBody>
      </p: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D4CD5B02-CF39-974E-8BB7-D42B8F246839}"/>
              </a:ext>
            </a:extLst>
          </p:cNvPr>
          <p:cNvCxnSpPr>
            <a:cxnSpLocks/>
          </p:cNvCxnSpPr>
          <p:nvPr/>
        </p:nvCxnSpPr>
        <p:spPr>
          <a:xfrm flipH="1">
            <a:off x="7827522" y="3274346"/>
            <a:ext cx="572078" cy="32172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6477001" y="4495801"/>
            <a:ext cx="1853287" cy="246221"/>
          </a:xfrm>
          <a:prstGeom prst="rect">
            <a:avLst/>
          </a:prstGeom>
          <a:noFill/>
          <a:ln>
            <a:noFill/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US" altLang="zh-CN" sz="1000">
                <a:solidFill>
                  <a:srgbClr val="FFFFFF"/>
                </a:solidFill>
              </a:rPr>
              <a:t>Posterior probability &gt;98.75% </a:t>
            </a:r>
            <a:endParaRPr lang="en-US" altLang="zh-CN" sz="1000">
              <a:solidFill>
                <a:srgbClr val="000000"/>
              </a:solidFill>
            </a:endParaRP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E0D7A2DC-27AA-482F-A34A-6D0B35B3F360}"/>
              </a:ext>
            </a:extLst>
          </p:cNvPr>
          <p:cNvGrpSpPr/>
          <p:nvPr/>
        </p:nvGrpSpPr>
        <p:grpSpPr>
          <a:xfrm>
            <a:off x="4067362" y="4371414"/>
            <a:ext cx="2488104" cy="320204"/>
            <a:chOff x="4267202" y="5438365"/>
            <a:chExt cx="2488104" cy="320204"/>
          </a:xfrm>
        </p:grpSpPr>
        <p:grpSp>
          <p:nvGrpSpPr>
            <p:cNvPr id="50" name="Group 138">
              <a:extLst>
                <a:ext uri="{FF2B5EF4-FFF2-40B4-BE49-F238E27FC236}">
                  <a16:creationId xmlns:a16="http://schemas.microsoft.com/office/drawing/2014/main" id="{96ADE701-0851-452F-B405-FEB7032062B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267202" y="5440365"/>
              <a:ext cx="2249620" cy="318204"/>
              <a:chOff x="3599542" y="6265456"/>
              <a:chExt cx="2249636" cy="317891"/>
            </a:xfrm>
          </p:grpSpPr>
          <p:pic>
            <p:nvPicPr>
              <p:cNvPr id="53" name="Picture 30" descr="blueColorbar">
                <a:extLst>
                  <a:ext uri="{FF2B5EF4-FFF2-40B4-BE49-F238E27FC236}">
                    <a16:creationId xmlns:a16="http://schemas.microsoft.com/office/drawing/2014/main" id="{899AB74F-EE3F-466B-B9DC-E4E843217108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4845364" y="6483261"/>
                <a:ext cx="1003814" cy="93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4" name="Picture 31" descr="redColorbar">
                <a:extLst>
                  <a:ext uri="{FF2B5EF4-FFF2-40B4-BE49-F238E27FC236}">
                    <a16:creationId xmlns:a16="http://schemas.microsoft.com/office/drawing/2014/main" id="{1670FB89-D46C-4B06-BDE5-5133B5425BD1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3711459" y="6489632"/>
                <a:ext cx="1139610" cy="937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5" name="Text Box 32">
                <a:extLst>
                  <a:ext uri="{FF2B5EF4-FFF2-40B4-BE49-F238E27FC236}">
                    <a16:creationId xmlns:a16="http://schemas.microsoft.com/office/drawing/2014/main" id="{60F7B96B-A40F-4ECD-BC21-1001393E6EF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599542" y="6265456"/>
                <a:ext cx="752041" cy="2459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1000" dirty="0">
                    <a:solidFill>
                      <a:schemeClr val="bg1"/>
                    </a:solidFill>
                    <a:cs typeface="Arial" charset="0"/>
                  </a:rPr>
                  <a:t> </a:t>
                </a:r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9.99%</a:t>
                </a:r>
                <a:endParaRPr lang="en-US" altLang="zh-CN" sz="1000" dirty="0">
                  <a:solidFill>
                    <a:schemeClr val="bg1"/>
                  </a:solidFill>
                  <a:cs typeface="Arial" charset="0"/>
                </a:endParaRPr>
              </a:p>
            </p:txBody>
          </p:sp>
          <p:sp>
            <p:nvSpPr>
              <p:cNvPr id="56" name="Text Box 32">
                <a:extLst>
                  <a:ext uri="{FF2B5EF4-FFF2-40B4-BE49-F238E27FC236}">
                    <a16:creationId xmlns:a16="http://schemas.microsoft.com/office/drawing/2014/main" id="{502BB817-FB6D-4D3A-8E94-88783376867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05323" y="6265456"/>
                <a:ext cx="630105" cy="2306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8.75% </a:t>
                </a:r>
              </a:p>
            </p:txBody>
          </p:sp>
        </p:grpSp>
        <p:sp>
          <p:nvSpPr>
            <p:cNvPr id="51" name="Text Box 32">
              <a:extLst>
                <a:ext uri="{FF2B5EF4-FFF2-40B4-BE49-F238E27FC236}">
                  <a16:creationId xmlns:a16="http://schemas.microsoft.com/office/drawing/2014/main" id="{441FFCE6-DCE4-4F35-8A8A-507FB8833B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88299" y="5440364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 -98.75%</a:t>
              </a:r>
            </a:p>
          </p:txBody>
        </p:sp>
        <p:sp>
          <p:nvSpPr>
            <p:cNvPr id="52" name="Text Box 32">
              <a:extLst>
                <a:ext uri="{FF2B5EF4-FFF2-40B4-BE49-F238E27FC236}">
                  <a16:creationId xmlns:a16="http://schemas.microsoft.com/office/drawing/2014/main" id="{3FD36810-40FF-4950-9B40-0260A85386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190" y="5438365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-99.99%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31497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45</Words>
  <Application>Microsoft Macintosh PowerPoint</Application>
  <PresentationFormat>Widescreen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hys Aghababian</dc:creator>
  <cp:lastModifiedBy>Microsoft Office User</cp:lastModifiedBy>
  <cp:revision>11</cp:revision>
  <dcterms:created xsi:type="dcterms:W3CDTF">2021-05-24T12:55:43Z</dcterms:created>
  <dcterms:modified xsi:type="dcterms:W3CDTF">2022-08-31T20:49:23Z</dcterms:modified>
</cp:coreProperties>
</file>